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80" d="100"/>
          <a:sy n="80" d="100"/>
        </p:scale>
        <p:origin x="20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9175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5133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392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63623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3855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8869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9004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7819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5987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941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017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28C32-F8AF-48B0-8595-B84F7706CC4B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44D65-25F7-4E55-9440-94B08ED50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553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E32D221C-9D68-4F44-9BDF-E374F20A66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6894" y="1063757"/>
            <a:ext cx="5327373" cy="5121547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214945" y="175990"/>
            <a:ext cx="2632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/>
              <a:t>Supplementary Fig. 1</a:t>
            </a:r>
            <a:endParaRPr lang="ja-JP" altLang="en-US" sz="2000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1022B06-A0F5-4B54-8364-FEE97972EDC3}"/>
              </a:ext>
            </a:extLst>
          </p:cNvPr>
          <p:cNvSpPr txBox="1"/>
          <p:nvPr/>
        </p:nvSpPr>
        <p:spPr>
          <a:xfrm>
            <a:off x="4790114" y="1396604"/>
            <a:ext cx="237543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ja-JP" altLang="en-US" sz="1400" dirty="0"/>
              <a:t>rho = 0.302, p &lt; 0.001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CA428B9-2A36-4021-A1AF-FE3D86A6CE47}"/>
              </a:ext>
            </a:extLst>
          </p:cNvPr>
          <p:cNvSpPr txBox="1"/>
          <p:nvPr/>
        </p:nvSpPr>
        <p:spPr>
          <a:xfrm>
            <a:off x="855678" y="6234095"/>
            <a:ext cx="7868872" cy="5688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erum </a:t>
            </a:r>
            <a:r>
              <a:rPr lang="en-US" altLang="ja-JP" sz="1100" kern="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sTNF</a:t>
            </a:r>
            <a:r>
              <a:rPr lang="en-US" altLang="ja-JP" sz="1100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α levels were significantly positively correlated with attention bias variability (rho = 0.302, p &lt; 0.001). </a:t>
            </a:r>
            <a:r>
              <a:rPr lang="en-US" altLang="ja-JP" sz="1100" i="1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bbreviation</a:t>
            </a:r>
            <a:r>
              <a:rPr lang="en-US" altLang="ja-JP" sz="1100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: </a:t>
            </a:r>
            <a:r>
              <a:rPr lang="en-US" altLang="ja-JP" sz="1100" kern="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sTNF</a:t>
            </a:r>
            <a:r>
              <a:rPr lang="en-US" altLang="ja-JP" sz="1100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α, high-sensitivity tumor necrosis factor-α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302814A-C4FC-4348-9755-8F96346D41C0}"/>
              </a:ext>
            </a:extLst>
          </p:cNvPr>
          <p:cNvSpPr txBox="1"/>
          <p:nvPr/>
        </p:nvSpPr>
        <p:spPr>
          <a:xfrm>
            <a:off x="717372" y="609149"/>
            <a:ext cx="786887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catterplot showing the relationship between serum </a:t>
            </a:r>
            <a:r>
              <a:rPr lang="en-US" altLang="ja-JP" sz="1400" kern="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sTNF</a:t>
            </a:r>
            <a:r>
              <a:rPr lang="en-US" altLang="ja-JP" sz="1400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α levels and attention bias variability.</a:t>
            </a:r>
            <a:endParaRPr lang="ja-JP" altLang="en-US" sz="14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E567FB9-63CF-4102-B8C8-873F21CEE542}"/>
              </a:ext>
            </a:extLst>
          </p:cNvPr>
          <p:cNvSpPr txBox="1"/>
          <p:nvPr/>
        </p:nvSpPr>
        <p:spPr>
          <a:xfrm>
            <a:off x="4404220" y="34056"/>
            <a:ext cx="457910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Hori H et al. </a:t>
            </a:r>
            <a:r>
              <a:rPr lang="ja-JP" alt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hildhood maltreatment history and attention bias</a:t>
            </a:r>
          </a:p>
        </p:txBody>
      </p:sp>
    </p:spTree>
    <p:extLst>
      <p:ext uri="{BB962C8B-B14F-4D97-AF65-F5344CB8AC3E}">
        <p14:creationId xmlns:p14="http://schemas.microsoft.com/office/powerpoint/2010/main" val="3658671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1</TotalTime>
  <Words>64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</dc:creator>
  <cp:lastModifiedBy>Hiroaki Hori</cp:lastModifiedBy>
  <cp:revision>34</cp:revision>
  <cp:lastPrinted>2019-07-26T04:20:10Z</cp:lastPrinted>
  <dcterms:created xsi:type="dcterms:W3CDTF">2019-07-26T03:50:10Z</dcterms:created>
  <dcterms:modified xsi:type="dcterms:W3CDTF">2020-12-26T09:04:12Z</dcterms:modified>
</cp:coreProperties>
</file>